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81"/>
  </p:normalViewPr>
  <p:slideViewPr>
    <p:cSldViewPr snapToGrid="0">
      <p:cViewPr varScale="1">
        <p:scale>
          <a:sx n="103" d="100"/>
          <a:sy n="103" d="100"/>
        </p:scale>
        <p:origin x="800"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83629B-4829-52F7-C505-F2A5F151419D}"/>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1C589810-62EE-6587-C942-FDF27BFB0F6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15E01379-D6A8-EECD-7082-234747B4A5C8}"/>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5" name="Footer Placeholder 4">
            <a:extLst>
              <a:ext uri="{FF2B5EF4-FFF2-40B4-BE49-F238E27FC236}">
                <a16:creationId xmlns:a16="http://schemas.microsoft.com/office/drawing/2014/main" id="{09137BE6-9A37-C7D9-531C-8EE16628260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2976B34-E9A6-2BC9-5F16-B14B3A5C1281}"/>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15854457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05B1BC-59B0-908D-6C16-6138D5CCD362}"/>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11E8535B-91B9-3B14-CC0B-9382FEC47F24}"/>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DCC28303-962F-AC1E-8FF8-F714B95CC6B4}"/>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5" name="Footer Placeholder 4">
            <a:extLst>
              <a:ext uri="{FF2B5EF4-FFF2-40B4-BE49-F238E27FC236}">
                <a16:creationId xmlns:a16="http://schemas.microsoft.com/office/drawing/2014/main" id="{68386106-67E4-7E95-0213-140ED9031C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6A466C-8BB3-BA56-C486-131A4581B883}"/>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7907064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9388767-689D-F891-0DD0-750D2B897657}"/>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D405E8D5-EA30-D5E5-20CA-42E69D8A47F9}"/>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3364BA1C-E163-EB7D-670B-02A1FB18C79B}"/>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5" name="Footer Placeholder 4">
            <a:extLst>
              <a:ext uri="{FF2B5EF4-FFF2-40B4-BE49-F238E27FC236}">
                <a16:creationId xmlns:a16="http://schemas.microsoft.com/office/drawing/2014/main" id="{6644B3C5-89BE-CFB1-89FF-528A693093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FED6BA-63E4-6704-DD88-F57C9EB7CC64}"/>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245282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E2B8A2-C9B9-CE5B-43E0-A3E36C83E097}"/>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C85B237D-84AC-368B-7D87-2E2939416EE7}"/>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47856F9D-B15B-7AC6-3127-8D8CB9C629D3}"/>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5" name="Footer Placeholder 4">
            <a:extLst>
              <a:ext uri="{FF2B5EF4-FFF2-40B4-BE49-F238E27FC236}">
                <a16:creationId xmlns:a16="http://schemas.microsoft.com/office/drawing/2014/main" id="{3FC55878-FD36-C89E-11AF-F57EABDD53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FB8B6C7-8D01-BF9C-9C49-EFBDD7D191ED}"/>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17756744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CB1111-5BE7-A8AC-252F-D0747C47FD25}"/>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FF5001B1-BB1B-8633-5C0E-1CEABE9AD2E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E37FE673-2651-4BBF-637B-A21B26948B96}"/>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5" name="Footer Placeholder 4">
            <a:extLst>
              <a:ext uri="{FF2B5EF4-FFF2-40B4-BE49-F238E27FC236}">
                <a16:creationId xmlns:a16="http://schemas.microsoft.com/office/drawing/2014/main" id="{BFED9351-D9BC-EB37-6E16-1B13433476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A37252-A952-A8E9-F5DB-CD73B23EAD2F}"/>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3613683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CF21CB-2A47-4BEE-A5B3-F4CAE4468F1D}"/>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2CB739FA-1917-BA04-B0D9-A89C65F8878A}"/>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D1D9FB99-6C83-4531-B010-76953AA5E2D8}"/>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CC65AB71-FAF8-ADC8-AACD-C32C3FEECF57}"/>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6" name="Footer Placeholder 5">
            <a:extLst>
              <a:ext uri="{FF2B5EF4-FFF2-40B4-BE49-F238E27FC236}">
                <a16:creationId xmlns:a16="http://schemas.microsoft.com/office/drawing/2014/main" id="{3156B4AE-7538-8326-44B8-9189D2BF642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7748254-952B-7C8F-97A0-BEA307DBB368}"/>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29093997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168BFB-D5D6-1E6F-3881-618C96E4DCBB}"/>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7D4C9057-24CF-80CA-EF1E-9CB0A88DEFA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7594790C-5CE6-C28B-9266-9730F189FBD1}"/>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DEE98176-C73B-5D0B-D630-155A2EAC5D1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45D79A23-872D-B25C-6DCF-882ECA84818A}"/>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6663E061-D038-BDF5-3D6B-5876980DDD73}"/>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8" name="Footer Placeholder 7">
            <a:extLst>
              <a:ext uri="{FF2B5EF4-FFF2-40B4-BE49-F238E27FC236}">
                <a16:creationId xmlns:a16="http://schemas.microsoft.com/office/drawing/2014/main" id="{34998E4B-FD7A-9556-425B-72714E04953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7A07AF8-3447-F2AE-C6E3-0F0C3FE8D5EA}"/>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12848396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BEFB63-9B38-A956-8668-74DD133DE8CD}"/>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F126BB05-CAE4-644B-D67B-26BA33CEED79}"/>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4" name="Footer Placeholder 3">
            <a:extLst>
              <a:ext uri="{FF2B5EF4-FFF2-40B4-BE49-F238E27FC236}">
                <a16:creationId xmlns:a16="http://schemas.microsoft.com/office/drawing/2014/main" id="{6BBB7F18-9A9D-DAB7-366F-9F3C928EBC4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D3EC736-25F2-2EFF-8BFE-EF6FD012F154}"/>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16281352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9838160-EF87-75EA-4BC4-F237B4F3604F}"/>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3" name="Footer Placeholder 2">
            <a:extLst>
              <a:ext uri="{FF2B5EF4-FFF2-40B4-BE49-F238E27FC236}">
                <a16:creationId xmlns:a16="http://schemas.microsoft.com/office/drawing/2014/main" id="{71CF0FD9-698B-867B-8E45-B9DB4EF3240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6E31EF6-EA77-0C22-06EF-B129BDE792EA}"/>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23463543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01484B-03FA-C5FF-2A34-FDAE1F1900A3}"/>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F87CC437-DCEA-3836-6461-0AA819573E9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0A1FDD8B-184A-B460-43E2-926ABA98A0A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549FD4C3-A6DB-B476-DFA6-9E0E98B0E4F1}"/>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6" name="Footer Placeholder 5">
            <a:extLst>
              <a:ext uri="{FF2B5EF4-FFF2-40B4-BE49-F238E27FC236}">
                <a16:creationId xmlns:a16="http://schemas.microsoft.com/office/drawing/2014/main" id="{F8D450EB-4997-AA48-EFF7-8BE27DF1425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70325B8-5031-CDA8-A855-6612B356D5B1}"/>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5181369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BAC1BE-CA46-947E-BE34-77A01F2E8BEB}"/>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7B65F324-1E48-DB6F-6906-D2182DD0287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7C0D591-0F7B-7F92-E765-DF9D45A6079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8DEB4B8-1F15-5F8E-543C-586918D9E082}"/>
              </a:ext>
            </a:extLst>
          </p:cNvPr>
          <p:cNvSpPr>
            <a:spLocks noGrp="1"/>
          </p:cNvSpPr>
          <p:nvPr>
            <p:ph type="dt" sz="half" idx="10"/>
          </p:nvPr>
        </p:nvSpPr>
        <p:spPr/>
        <p:txBody>
          <a:bodyPr/>
          <a:lstStyle/>
          <a:p>
            <a:fld id="{DA33230F-973E-EE48-A717-BA66DA5A405A}" type="datetimeFigureOut">
              <a:rPr lang="en-US" smtClean="0"/>
              <a:t>12/21/22</a:t>
            </a:fld>
            <a:endParaRPr lang="en-US"/>
          </a:p>
        </p:txBody>
      </p:sp>
      <p:sp>
        <p:nvSpPr>
          <p:cNvPr id="6" name="Footer Placeholder 5">
            <a:extLst>
              <a:ext uri="{FF2B5EF4-FFF2-40B4-BE49-F238E27FC236}">
                <a16:creationId xmlns:a16="http://schemas.microsoft.com/office/drawing/2014/main" id="{38079FED-F012-2755-E9C5-422F5CBEA54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8976A52-0F5F-945F-0EBE-89F24B6F6E66}"/>
              </a:ext>
            </a:extLst>
          </p:cNvPr>
          <p:cNvSpPr>
            <a:spLocks noGrp="1"/>
          </p:cNvSpPr>
          <p:nvPr>
            <p:ph type="sldNum" sz="quarter" idx="12"/>
          </p:nvPr>
        </p:nvSpPr>
        <p:spPr/>
        <p:txBody>
          <a:bodyPr/>
          <a:lstStyle/>
          <a:p>
            <a:fld id="{44556285-D5DD-5543-AABB-2A17F8D754A8}" type="slidenum">
              <a:rPr lang="en-US" smtClean="0"/>
              <a:t>‹#›</a:t>
            </a:fld>
            <a:endParaRPr lang="en-US"/>
          </a:p>
        </p:txBody>
      </p:sp>
    </p:spTree>
    <p:extLst>
      <p:ext uri="{BB962C8B-B14F-4D97-AF65-F5344CB8AC3E}">
        <p14:creationId xmlns:p14="http://schemas.microsoft.com/office/powerpoint/2010/main" val="14854707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6031AF4-6A7F-7E16-FE44-EEDBB46BCE4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EBD136E0-0218-4CE3-E3EC-C12DBB224DD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3BCECF56-01E5-6921-4BB0-864B3190303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A33230F-973E-EE48-A717-BA66DA5A405A}" type="datetimeFigureOut">
              <a:rPr lang="en-US" smtClean="0"/>
              <a:t>12/21/22</a:t>
            </a:fld>
            <a:endParaRPr lang="en-US"/>
          </a:p>
        </p:txBody>
      </p:sp>
      <p:sp>
        <p:nvSpPr>
          <p:cNvPr id="5" name="Footer Placeholder 4">
            <a:extLst>
              <a:ext uri="{FF2B5EF4-FFF2-40B4-BE49-F238E27FC236}">
                <a16:creationId xmlns:a16="http://schemas.microsoft.com/office/drawing/2014/main" id="{CCAE3F7B-E7E0-5D18-ECAF-C41C770BE88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D5F8BE3-11D7-34F4-FC3D-6CE2DDB91D1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4556285-D5DD-5543-AABB-2A17F8D754A8}" type="slidenum">
              <a:rPr lang="en-US" smtClean="0"/>
              <a:t>‹#›</a:t>
            </a:fld>
            <a:endParaRPr lang="en-US"/>
          </a:p>
        </p:txBody>
      </p:sp>
    </p:spTree>
    <p:extLst>
      <p:ext uri="{BB962C8B-B14F-4D97-AF65-F5344CB8AC3E}">
        <p14:creationId xmlns:p14="http://schemas.microsoft.com/office/powerpoint/2010/main" val="9689874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D55368DD-3551-A3E3-1EB3-45C0FB0077F0}"/>
              </a:ext>
            </a:extLst>
          </p:cNvPr>
          <p:cNvSpPr txBox="1"/>
          <p:nvPr/>
        </p:nvSpPr>
        <p:spPr>
          <a:xfrm>
            <a:off x="528252" y="1024751"/>
            <a:ext cx="8788741" cy="923330"/>
          </a:xfrm>
          <a:prstGeom prst="rect">
            <a:avLst/>
          </a:prstGeom>
          <a:noFill/>
        </p:spPr>
        <p:txBody>
          <a:bodyPr wrap="square">
            <a:spAutoFit/>
          </a:bodyPr>
          <a:lstStyle/>
          <a:p>
            <a:r>
              <a:rPr lang="en-IN" dirty="0"/>
              <a:t>&gt;AAH32338.1 Metallothionein 1X [Homo sapiens] MDPNCSCSPVGSCACAGSCKCKECKCTSCK</a:t>
            </a:r>
            <a:r>
              <a:rPr lang="en-IN" dirty="0">
                <a:solidFill>
                  <a:srgbClr val="FF0000"/>
                </a:solidFill>
              </a:rPr>
              <a:t>KSCCSCCPVGCAK</a:t>
            </a:r>
            <a:r>
              <a:rPr lang="en-IN" dirty="0">
                <a:solidFill>
                  <a:srgbClr val="0070C0"/>
                </a:solidFill>
              </a:rPr>
              <a:t>CAQGCICK</a:t>
            </a:r>
            <a:r>
              <a:rPr lang="en-IN" dirty="0"/>
              <a:t>GTSDKCSCCA </a:t>
            </a:r>
            <a:br>
              <a:rPr lang="en-IN" dirty="0"/>
            </a:br>
            <a:endParaRPr lang="en-US" dirty="0"/>
          </a:p>
        </p:txBody>
      </p:sp>
      <p:grpSp>
        <p:nvGrpSpPr>
          <p:cNvPr id="9" name="Group 8">
            <a:extLst>
              <a:ext uri="{FF2B5EF4-FFF2-40B4-BE49-F238E27FC236}">
                <a16:creationId xmlns:a16="http://schemas.microsoft.com/office/drawing/2014/main" id="{6ADF42BC-8FA2-294A-295E-B70F9F2A0EF5}"/>
              </a:ext>
            </a:extLst>
          </p:cNvPr>
          <p:cNvGrpSpPr/>
          <p:nvPr/>
        </p:nvGrpSpPr>
        <p:grpSpPr>
          <a:xfrm>
            <a:off x="528252" y="2782669"/>
            <a:ext cx="8788742" cy="646331"/>
            <a:chOff x="741405" y="4153584"/>
            <a:chExt cx="8788742" cy="646331"/>
          </a:xfrm>
        </p:grpSpPr>
        <p:sp>
          <p:nvSpPr>
            <p:cNvPr id="5" name="TextBox 4">
              <a:extLst>
                <a:ext uri="{FF2B5EF4-FFF2-40B4-BE49-F238E27FC236}">
                  <a16:creationId xmlns:a16="http://schemas.microsoft.com/office/drawing/2014/main" id="{D3F346F2-1070-E82B-6CA0-6433704B9BBE}"/>
                </a:ext>
              </a:extLst>
            </p:cNvPr>
            <p:cNvSpPr txBox="1"/>
            <p:nvPr/>
          </p:nvSpPr>
          <p:spPr>
            <a:xfrm>
              <a:off x="741405" y="4153584"/>
              <a:ext cx="8788742" cy="646331"/>
            </a:xfrm>
            <a:prstGeom prst="rect">
              <a:avLst/>
            </a:prstGeom>
            <a:noFill/>
          </p:spPr>
          <p:txBody>
            <a:bodyPr wrap="square">
              <a:spAutoFit/>
            </a:bodyPr>
            <a:lstStyle/>
            <a:p>
              <a:r>
                <a:rPr lang="en-IN" dirty="0"/>
                <a:t>&gt;CAA65915.1 Metallothionein 2 [Homo sapiens] </a:t>
              </a:r>
              <a:r>
                <a:rPr lang="en-IN" dirty="0">
                  <a:solidFill>
                    <a:srgbClr val="FF0000"/>
                  </a:solidFill>
                </a:rPr>
                <a:t>MDPNCSCAAGDSCTCAGSCKCKECKCTSCK</a:t>
              </a:r>
              <a:r>
                <a:rPr lang="en-IN" dirty="0">
                  <a:solidFill>
                    <a:schemeClr val="accent6">
                      <a:lumMod val="75000"/>
                    </a:schemeClr>
                  </a:solidFill>
                </a:rPr>
                <a:t>KSCCSCCPVGCAK</a:t>
              </a:r>
              <a:r>
                <a:rPr lang="en-IN" dirty="0">
                  <a:solidFill>
                    <a:srgbClr val="0070C0"/>
                  </a:solidFill>
                </a:rPr>
                <a:t>CAQGCICK</a:t>
              </a:r>
              <a:r>
                <a:rPr lang="en-IN" dirty="0"/>
                <a:t>GASDKCSCCA</a:t>
              </a:r>
              <a:endParaRPr lang="en-US" dirty="0"/>
            </a:p>
          </p:txBody>
        </p:sp>
        <p:sp>
          <p:nvSpPr>
            <p:cNvPr id="8" name="Rectangle 7">
              <a:extLst>
                <a:ext uri="{FF2B5EF4-FFF2-40B4-BE49-F238E27FC236}">
                  <a16:creationId xmlns:a16="http://schemas.microsoft.com/office/drawing/2014/main" id="{2EF0955A-C810-48DA-0C61-254539F94565}"/>
                </a:ext>
              </a:extLst>
            </p:cNvPr>
            <p:cNvSpPr/>
            <p:nvPr/>
          </p:nvSpPr>
          <p:spPr>
            <a:xfrm>
              <a:off x="1680519" y="4476749"/>
              <a:ext cx="1223319" cy="32316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3" name="TextBox 12">
            <a:extLst>
              <a:ext uri="{FF2B5EF4-FFF2-40B4-BE49-F238E27FC236}">
                <a16:creationId xmlns:a16="http://schemas.microsoft.com/office/drawing/2014/main" id="{F0C29862-B063-E7E3-116C-D8ED163CBC53}"/>
              </a:ext>
            </a:extLst>
          </p:cNvPr>
          <p:cNvSpPr txBox="1"/>
          <p:nvPr/>
        </p:nvSpPr>
        <p:spPr>
          <a:xfrm>
            <a:off x="528252" y="1900367"/>
            <a:ext cx="8170905" cy="646331"/>
          </a:xfrm>
          <a:prstGeom prst="rect">
            <a:avLst/>
          </a:prstGeom>
          <a:noFill/>
        </p:spPr>
        <p:txBody>
          <a:bodyPr wrap="square">
            <a:spAutoFit/>
          </a:bodyPr>
          <a:lstStyle/>
          <a:p>
            <a:r>
              <a:rPr lang="en-IN" dirty="0"/>
              <a:t>&gt;AAI03842.1 Metallothionein 1M [Homo sapiens] MDPNCSCTTGVSCACTGSCKCKECKCTSCK</a:t>
            </a:r>
            <a:r>
              <a:rPr lang="en-IN" dirty="0">
                <a:solidFill>
                  <a:srgbClr val="FF0000"/>
                </a:solidFill>
              </a:rPr>
              <a:t>KSCCSCCPVGCAK</a:t>
            </a:r>
            <a:r>
              <a:rPr lang="en-IN" dirty="0"/>
              <a:t>CAHGCVCKGTLENCSCCA</a:t>
            </a:r>
            <a:endParaRPr lang="en-US" dirty="0"/>
          </a:p>
        </p:txBody>
      </p:sp>
      <p:sp>
        <p:nvSpPr>
          <p:cNvPr id="2" name="TextBox 1">
            <a:extLst>
              <a:ext uri="{FF2B5EF4-FFF2-40B4-BE49-F238E27FC236}">
                <a16:creationId xmlns:a16="http://schemas.microsoft.com/office/drawing/2014/main" id="{8EEDDEC0-1D1C-C2C4-BBDC-182D90B30EFA}"/>
              </a:ext>
            </a:extLst>
          </p:cNvPr>
          <p:cNvSpPr txBox="1"/>
          <p:nvPr/>
        </p:nvSpPr>
        <p:spPr>
          <a:xfrm>
            <a:off x="528252" y="4040660"/>
            <a:ext cx="10219038" cy="1477328"/>
          </a:xfrm>
          <a:prstGeom prst="rect">
            <a:avLst/>
          </a:prstGeom>
          <a:noFill/>
        </p:spPr>
        <p:txBody>
          <a:bodyPr wrap="square" rtlCol="0">
            <a:spAutoFit/>
          </a:bodyPr>
          <a:lstStyle/>
          <a:p>
            <a:r>
              <a:rPr lang="en-US" b="1" dirty="0"/>
              <a:t>Supplementary Figure 7</a:t>
            </a:r>
            <a:r>
              <a:rPr lang="en-US" dirty="0"/>
              <a:t>. Metallothionein peptides identified in the plasma of ACLF patients have been highlighted in red, green and blue fonts. The boxed sequence in metallothionein 2 shows the sequence unique to this protein which was detectable in the patient plasma suggesting that MT2 is the major circulating isoform in ACLF. However, we cannot rule out the presence of the MT1X and MT1M isoforms completely based on </a:t>
            </a:r>
            <a:r>
              <a:rPr lang="en-US"/>
              <a:t>this data. </a:t>
            </a:r>
            <a:endParaRPr lang="en-US" dirty="0"/>
          </a:p>
        </p:txBody>
      </p:sp>
    </p:spTree>
    <p:extLst>
      <p:ext uri="{BB962C8B-B14F-4D97-AF65-F5344CB8AC3E}">
        <p14:creationId xmlns:p14="http://schemas.microsoft.com/office/powerpoint/2010/main" val="34833571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1</TotalTime>
  <Words>103</Words>
  <Application>Microsoft Macintosh PowerPoint</Application>
  <PresentationFormat>Widescreen</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agyan Acharya</dc:creator>
  <cp:lastModifiedBy>Pragyan Acharya</cp:lastModifiedBy>
  <cp:revision>11</cp:revision>
  <dcterms:created xsi:type="dcterms:W3CDTF">2022-12-15T09:20:51Z</dcterms:created>
  <dcterms:modified xsi:type="dcterms:W3CDTF">2022-12-21T10:52:55Z</dcterms:modified>
</cp:coreProperties>
</file>